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979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AABC18-B391-414D-9091-2A409C860EB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44FC25-2734-4643-B5F0-7817B10AE2F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013D12-B967-4A21-ACB0-4FB77DAF194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C74998-FD79-43AB-B988-236C7041632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18F845-DB0C-46FF-91D4-CFBE4CBB2E0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A82C0D-6E28-4E99-A412-EC480951383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EEDB53-1A0A-4F0D-9FB5-D5BE55AB104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B2524E-90AA-4587-BD70-4E17968B83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37C257-FAFA-4552-88B8-2F600C24DDA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45C98D-3522-471F-907E-B9AAA0ECE5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07C6BD-A2D8-48A7-970B-D8FB6CC5A2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792DAE-F6A2-461F-8DBA-820DBA0A87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20E51E8-1B99-41A7-BD48-950A1652EE1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57200" y="228600"/>
            <a:ext cx="2895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Human NAIP 5’ UTR Splice Isoform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429000" y="762120"/>
            <a:ext cx="685800" cy="1522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4114800" y="838080"/>
            <a:ext cx="2971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4648320" y="762120"/>
            <a:ext cx="228600" cy="152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505320" y="593640"/>
            <a:ext cx="106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LTR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4343400" y="593640"/>
            <a:ext cx="106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HAL1:Aluj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5486400" y="762120"/>
            <a:ext cx="152280" cy="152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6858000" y="685800"/>
            <a:ext cx="380880" cy="304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6781680" y="517680"/>
            <a:ext cx="1067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T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429000" y="1311120"/>
            <a:ext cx="685800" cy="152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4114800" y="1387440"/>
            <a:ext cx="3048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3505320" y="1143000"/>
            <a:ext cx="106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LTR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5486400" y="1311120"/>
            <a:ext cx="152280" cy="152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6858000" y="1235160"/>
            <a:ext cx="380880" cy="3045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6781680" y="1219320"/>
            <a:ext cx="1067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T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3429000" y="1905120"/>
            <a:ext cx="685800" cy="1522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114800" y="1981080"/>
            <a:ext cx="3048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505320" y="1736640"/>
            <a:ext cx="106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LTR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6858000" y="1828800"/>
            <a:ext cx="380880" cy="304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6781680" y="1660680"/>
            <a:ext cx="1067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T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2743200" y="2666880"/>
            <a:ext cx="152280" cy="152640"/>
          </a:xfrm>
          <a:prstGeom prst="rect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2895480" y="2743200"/>
            <a:ext cx="4038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4648320" y="2666880"/>
            <a:ext cx="228600" cy="152640"/>
          </a:xfrm>
          <a:prstGeom prst="rect">
            <a:avLst/>
          </a:prstGeom>
          <a:solidFill>
            <a:srgbClr val="ff99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4343400" y="2498760"/>
            <a:ext cx="106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HAL1:Aluj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5486400" y="2666880"/>
            <a:ext cx="152280" cy="152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6858000" y="2590920"/>
            <a:ext cx="762120" cy="3045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3048120" y="2666880"/>
            <a:ext cx="228600" cy="152640"/>
          </a:xfrm>
          <a:prstGeom prst="rect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6781680" y="2422440"/>
            <a:ext cx="1067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T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2743200" y="3124080"/>
            <a:ext cx="152280" cy="15264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2895480" y="3200400"/>
            <a:ext cx="4038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5486400" y="3124080"/>
            <a:ext cx="152280" cy="152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6858000" y="3048120"/>
            <a:ext cx="762120" cy="3045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2743200" y="3124080"/>
            <a:ext cx="533520" cy="152640"/>
          </a:xfrm>
          <a:prstGeom prst="rect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6781680" y="2879640"/>
            <a:ext cx="1067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T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2743200" y="3733920"/>
            <a:ext cx="152280" cy="152280"/>
          </a:xfrm>
          <a:prstGeom prst="rect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2895480" y="3809880"/>
            <a:ext cx="4038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5486400" y="3733920"/>
            <a:ext cx="152280" cy="15228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6858000" y="3657600"/>
            <a:ext cx="762120" cy="304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3048120" y="3733920"/>
            <a:ext cx="228600" cy="152280"/>
          </a:xfrm>
          <a:prstGeom prst="rect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6781680" y="3489480"/>
            <a:ext cx="1067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T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2743200" y="4343400"/>
            <a:ext cx="152280" cy="152280"/>
          </a:xfrm>
          <a:prstGeom prst="rect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2895480" y="4419720"/>
            <a:ext cx="4038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6858000" y="4267080"/>
            <a:ext cx="762120" cy="304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3048120" y="4343400"/>
            <a:ext cx="228600" cy="152280"/>
          </a:xfrm>
          <a:prstGeom prst="rect">
            <a:avLst/>
          </a:prstGeom>
          <a:solidFill>
            <a:srgbClr val="00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6781680" y="4098960"/>
            <a:ext cx="1067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T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4267080" y="5029200"/>
            <a:ext cx="990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S-MIR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4114800" y="5334120"/>
            <a:ext cx="4191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3657600" y="5257800"/>
            <a:ext cx="457200" cy="2286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4495680" y="5257800"/>
            <a:ext cx="228600" cy="228600"/>
          </a:xfrm>
          <a:prstGeom prst="rect">
            <a:avLst/>
          </a:prstGeom>
          <a:solidFill>
            <a:srgbClr val="ff66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5257800" y="5257800"/>
            <a:ext cx="304920" cy="2286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8305920" y="5257800"/>
            <a:ext cx="152280" cy="2286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3581280" y="5089680"/>
            <a:ext cx="1067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T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4114800" y="5807160"/>
            <a:ext cx="4191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3657600" y="5730840"/>
            <a:ext cx="457200" cy="2286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5257800" y="5730840"/>
            <a:ext cx="304920" cy="2286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8305920" y="5730840"/>
            <a:ext cx="152280" cy="2286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3581280" y="5562720"/>
            <a:ext cx="1067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T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4114800" y="6324480"/>
            <a:ext cx="4191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3657600" y="6248520"/>
            <a:ext cx="457200" cy="2286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8305920" y="6248520"/>
            <a:ext cx="152280" cy="2286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3581280" y="6080040"/>
            <a:ext cx="1067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T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2666880" y="2482920"/>
            <a:ext cx="1067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MER21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2666880" y="2940120"/>
            <a:ext cx="1067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MER21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2666880" y="3549600"/>
            <a:ext cx="1067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MER21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2666880" y="4159080"/>
            <a:ext cx="1067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MER21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6781680" y="1050840"/>
            <a:ext cx="1067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AT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457200" y="533520"/>
            <a:ext cx="8229600" cy="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457200" y="4678200"/>
            <a:ext cx="3581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Human NAIP Open Reading Frame Splice Isoform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457200" y="4952880"/>
            <a:ext cx="8229600" cy="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228600" y="6858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4648320" y="2666880"/>
            <a:ext cx="136440" cy="15264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4648320" y="762120"/>
            <a:ext cx="228600" cy="152280"/>
          </a:xfrm>
          <a:prstGeom prst="rect">
            <a:avLst/>
          </a:prstGeom>
          <a:solidFill>
            <a:srgbClr val="ff99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4648320" y="762120"/>
            <a:ext cx="136440" cy="152280"/>
          </a:xfrm>
          <a:prstGeom prst="rect">
            <a:avLst/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228600" y="25146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228600" y="46782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3886200" y="990720"/>
            <a:ext cx="152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 flipH="1">
            <a:off x="4679640" y="990720"/>
            <a:ext cx="152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5486400" y="1066680"/>
            <a:ext cx="152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 flipH="1">
            <a:off x="6933960" y="1066680"/>
            <a:ext cx="1522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5740560" y="932040"/>
            <a:ext cx="1143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qPCR OR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3828960" y="932040"/>
            <a:ext cx="1143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qPCR LT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7-24T22:21:16Z</dcterms:created>
  <dc:creator>mromanis</dc:creator>
  <dc:description/>
  <dc:language>en-US</dc:language>
  <cp:lastModifiedBy>mromanis</cp:lastModifiedBy>
  <dcterms:modified xsi:type="dcterms:W3CDTF">2006-11-30T20:02:41Z</dcterms:modified>
  <cp:revision>16</cp:revision>
  <dc:subject/>
  <dc:title>Slide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r8>-364482811</vt:r8>
  </property>
  <property fmtid="{D5CDD505-2E9C-101B-9397-08002B2CF9AE}" pid="3" name="_AuthorEmail">
    <vt:lpwstr>mromanis@bccrc.ca</vt:lpwstr>
  </property>
  <property fmtid="{D5CDD505-2E9C-101B-9397-08002B2CF9AE}" pid="4" name="_AuthorEmailDisplayName">
    <vt:lpwstr>Mark Romanish</vt:lpwstr>
  </property>
  <property fmtid="{D5CDD505-2E9C-101B-9397-08002B2CF9AE}" pid="5" name="_EmailSubject">
    <vt:lpwstr>Synopsis</vt:lpwstr>
  </property>
</Properties>
</file>